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50" d="100"/>
          <a:sy n="50" d="100"/>
        </p:scale>
        <p:origin x="1284" y="4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7EE010-50D5-4D87-BC31-3B76774088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A1D8184-721F-47F9-AD04-5BFF705C09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509933-5747-4BD0-93ED-C63ABF142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83C0DB-6265-4011-BFB2-824C1CC71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01E1CC-BB62-4836-B0EF-2784CC1FF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362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462969-52FB-416C-A7E6-155253E501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7BFF8DC-D022-4F2A-BF55-764FC03E89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76E852-D554-4BEB-98A9-942A0D6F0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65D7A5-57D9-40E9-9043-DAFE4BAA0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24C90D4-424B-4AC0-A361-188F997350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8873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39331B7-926F-4544-BB40-8FF6D83BF9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71C41A8-8898-4A01-88CB-E1B1074A8A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490D6B2-1B20-4AAB-BC74-115EA63003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5A8C24-EBBC-42A5-95D7-1FE07DD80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BB7669-A15A-4141-8B24-CA3968014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02528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DF81A7-ACDA-460E-A4CB-BC548C89D8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9CA42C-5D35-4831-A46A-38CAF6B536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F94564-924C-442C-9DA3-38CCDF20F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6BDB37-C163-4151-97AF-DA5B091B6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628AA6-989D-45B0-9072-9729F86C29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4503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D5EFDB-CF7C-4E73-B1B5-B346988C79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D5964D6-4507-48B3-854C-14F9998A8B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02B1E7-38F5-4874-9491-01DCD5AEED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CE03A6-DA69-4E34-90C8-905EF611E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7F08AC-E121-4971-8B60-3808A0D008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901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4F2DE6-0D51-4096-AC50-5CEC9F709D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70DB048-0F0C-482D-8330-054B1FF864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3234DDD-CD76-42CD-B49C-164FE3DD08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4D0300C-2FD0-40AD-8CD8-1F8BEAE2D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7B39BE6-FA5A-44E9-A524-9169AC185A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8EC1B2E-5761-402B-AB58-933050289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5361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F219CC-3B42-4010-8924-0ED328DDC2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EFFBB4D-0372-4410-9E6A-9F31659924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BF9500C-9F8C-4136-85A4-F5D31803E9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BB4EB45-4E22-4B98-BF04-A610BCD158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4B6AC80-4992-41E7-942C-46A45C9AE9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6BC6E53-E669-4937-BB36-B39AA9AB4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A568554-B437-405F-82A4-E1784AE40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4296B09-FCC7-4FCD-934F-7B3302EE0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6508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BF0E2E-7BE2-43E4-B16F-DEAD384251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CA243C3-9B97-436A-9CB2-CF2B6C150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049E189-9528-4A33-BDF9-40F932A4B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B8655B1-A7A5-4513-BED6-BE79B2D044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8555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E4DDFB0-AF09-4FBC-8215-1B4749C535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4769B19-8F44-4494-9474-A3CACD5D7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E365D65-05B0-424D-A3AB-63317D9F2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2847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284159-47BB-43BB-869D-C62E5213AF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0B1FB85-5002-42E3-BE76-FACDE15CA9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E8E1D86-4531-45FD-815F-A7A2D04D27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0F881E1-50EA-4294-A5FD-227FA8EFEA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5FBABA4-A3A3-4477-ADF0-192B72DD8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1614749-A8D1-44AA-B857-B72E91410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8890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8DF5B5-3162-4028-ADC8-57A51015EE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F3E4CBD-3581-415F-BCC1-221450D305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66EF97A-4E90-4223-B9FF-FEC45BC60B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A7CFCA2-3172-4644-9750-E09724E8D5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DCCCD8F-D417-494A-959B-BCF032439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9B063C4-8BFD-4E29-9247-B29FA90D6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9636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D31C396-AB96-451A-B961-FA3DF0CE0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3A46EA2-A70D-48B5-874E-55C638143B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C804F5-1D9C-4A60-8D4B-C38AD49E8D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38620-F2E4-4C83-AE34-D353190EB12D}" type="datetimeFigureOut">
              <a:rPr lang="zh-CN" altLang="en-US" smtClean="0"/>
              <a:t>2021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9981DF-D376-463F-8B55-5DBF6A3DF6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647EA4-255D-4906-9450-023A64A3D3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A9A76-D333-4499-8C81-60803EA686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8123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microsoft.com/office/2007/relationships/hdphoto" Target="../media/hdphoto3.wdp"/><Relationship Id="rId4" Type="http://schemas.microsoft.com/office/2007/relationships/hdphoto" Target="../media/hdphoto1.wdp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eg"/><Relationship Id="rId3" Type="http://schemas.openxmlformats.org/officeDocument/2006/relationships/image" Target="../media/image17.jpeg"/><Relationship Id="rId7" Type="http://schemas.openxmlformats.org/officeDocument/2006/relationships/image" Target="../media/image21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jpeg"/><Relationship Id="rId5" Type="http://schemas.openxmlformats.org/officeDocument/2006/relationships/image" Target="../media/image19.jpeg"/><Relationship Id="rId10" Type="http://schemas.openxmlformats.org/officeDocument/2006/relationships/image" Target="../media/image24.jpeg"/><Relationship Id="rId4" Type="http://schemas.openxmlformats.org/officeDocument/2006/relationships/image" Target="../media/image18.jpeg"/><Relationship Id="rId9" Type="http://schemas.openxmlformats.org/officeDocument/2006/relationships/image" Target="../media/image23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eg"/><Relationship Id="rId3" Type="http://schemas.openxmlformats.org/officeDocument/2006/relationships/image" Target="../media/image26.jpeg"/><Relationship Id="rId7" Type="http://schemas.openxmlformats.org/officeDocument/2006/relationships/image" Target="../media/image30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jpeg"/><Relationship Id="rId5" Type="http://schemas.openxmlformats.org/officeDocument/2006/relationships/image" Target="../media/image28.jpeg"/><Relationship Id="rId10" Type="http://schemas.openxmlformats.org/officeDocument/2006/relationships/image" Target="../media/image33.jpeg"/><Relationship Id="rId4" Type="http://schemas.openxmlformats.org/officeDocument/2006/relationships/image" Target="../media/image27.jpeg"/><Relationship Id="rId9" Type="http://schemas.openxmlformats.org/officeDocument/2006/relationships/image" Target="../media/image32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jpg"/><Relationship Id="rId3" Type="http://schemas.openxmlformats.org/officeDocument/2006/relationships/image" Target="../media/image35.jpg"/><Relationship Id="rId7" Type="http://schemas.openxmlformats.org/officeDocument/2006/relationships/image" Target="../media/image39.jpg"/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jpg"/><Relationship Id="rId5" Type="http://schemas.openxmlformats.org/officeDocument/2006/relationships/image" Target="../media/image37.jpg"/><Relationship Id="rId4" Type="http://schemas.openxmlformats.org/officeDocument/2006/relationships/image" Target="../media/image36.jpg"/><Relationship Id="rId9" Type="http://schemas.openxmlformats.org/officeDocument/2006/relationships/image" Target="../media/image4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C6E90FB-0806-4BEC-B583-82CF8E1240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04076" y="519773"/>
            <a:ext cx="2923012" cy="355516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05C6DB7-D767-48FB-9B63-67DE84D145D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6459" y="4245056"/>
            <a:ext cx="2558246" cy="177297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5466647-D0F2-4109-9E1E-D1701D7156F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47205" y="519773"/>
            <a:ext cx="2841968" cy="355516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BC5AA2E-E954-49D2-BA8F-906E1F8232F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29585" y="4245056"/>
            <a:ext cx="2558246" cy="177297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79488B8-0A89-4753-8CF7-393432BD854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H="1">
            <a:off x="7109290" y="519773"/>
            <a:ext cx="2847369" cy="3555161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39065B81-7577-4200-8300-960A66663656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53851" y="4245056"/>
            <a:ext cx="2558246" cy="177297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4F6934D0-4AB7-4DB9-94E2-20E7292BE7F0}"/>
              </a:ext>
            </a:extLst>
          </p:cNvPr>
          <p:cNvSpPr txBox="1"/>
          <p:nvPr/>
        </p:nvSpPr>
        <p:spPr>
          <a:xfrm>
            <a:off x="7869456" y="-6003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>
                <a:latin typeface="微软雅黑" panose="020B0503020204020204" pitchFamily="34" charset="-122"/>
                <a:ea typeface="微软雅黑" panose="020B0503020204020204" pitchFamily="34" charset="-122"/>
              </a:rPr>
              <a:t>DMM+Bai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D90911C-FE28-4FB9-A8D1-9698F5A5B4AD}"/>
              </a:ext>
            </a:extLst>
          </p:cNvPr>
          <p:cNvSpPr txBox="1"/>
          <p:nvPr/>
        </p:nvSpPr>
        <p:spPr>
          <a:xfrm>
            <a:off x="4798732" y="-6003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DM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3600503-D10A-4C96-8347-5B4DBD445D65}"/>
              </a:ext>
            </a:extLst>
          </p:cNvPr>
          <p:cNvSpPr txBox="1"/>
          <p:nvPr/>
        </p:nvSpPr>
        <p:spPr>
          <a:xfrm>
            <a:off x="1829191" y="-6003"/>
            <a:ext cx="1072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Sha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2894B74-B5A5-4CB8-A621-A929EE806592}"/>
              </a:ext>
            </a:extLst>
          </p:cNvPr>
          <p:cNvSpPr txBox="1"/>
          <p:nvPr/>
        </p:nvSpPr>
        <p:spPr>
          <a:xfrm>
            <a:off x="3969879" y="6338227"/>
            <a:ext cx="3788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Figure 4 Knee joint HE staining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BAD75174-D123-49C8-B6D3-D99234461DE0}"/>
              </a:ext>
            </a:extLst>
          </p:cNvPr>
          <p:cNvSpPr/>
          <p:nvPr/>
        </p:nvSpPr>
        <p:spPr>
          <a:xfrm>
            <a:off x="1318436" y="1864581"/>
            <a:ext cx="422899" cy="5738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CAFA79A9-FAF1-45C4-8B95-8B64E2A6A8E4}"/>
              </a:ext>
            </a:extLst>
          </p:cNvPr>
          <p:cNvSpPr/>
          <p:nvPr/>
        </p:nvSpPr>
        <p:spPr>
          <a:xfrm>
            <a:off x="4241447" y="1498049"/>
            <a:ext cx="444097" cy="6213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9AB9301D-C321-4230-8009-2F0325843E3C}"/>
              </a:ext>
            </a:extLst>
          </p:cNvPr>
          <p:cNvSpPr/>
          <p:nvPr/>
        </p:nvSpPr>
        <p:spPr>
          <a:xfrm>
            <a:off x="7230291" y="1883228"/>
            <a:ext cx="302623" cy="4724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29000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AD64479-5208-4095-9CD9-B79F78C4CB4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12887" y="1202807"/>
            <a:ext cx="2929850" cy="3486151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121A5B7-A472-480A-9CB7-CC2938CAE94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48051" y="1202807"/>
            <a:ext cx="2929850" cy="3486151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51F100E3-A110-4578-9D4E-A4D6DBC9F62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683215" y="1202807"/>
            <a:ext cx="2929850" cy="348615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21719DD-B855-42BA-A2B7-78B94F51B9D6}"/>
              </a:ext>
            </a:extLst>
          </p:cNvPr>
          <p:cNvSpPr txBox="1"/>
          <p:nvPr/>
        </p:nvSpPr>
        <p:spPr>
          <a:xfrm>
            <a:off x="8624368" y="685114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>
                <a:latin typeface="微软雅黑" panose="020B0503020204020204" pitchFamily="34" charset="-122"/>
                <a:ea typeface="微软雅黑" panose="020B0503020204020204" pitchFamily="34" charset="-122"/>
              </a:rPr>
              <a:t>DMM+Bai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CF3B87F-E1FA-4387-B9A6-9929DE8EA1DE}"/>
              </a:ext>
            </a:extLst>
          </p:cNvPr>
          <p:cNvSpPr txBox="1"/>
          <p:nvPr/>
        </p:nvSpPr>
        <p:spPr>
          <a:xfrm>
            <a:off x="5096619" y="685114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DM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9AB3992-478E-47F8-91C8-258BC10F7F52}"/>
              </a:ext>
            </a:extLst>
          </p:cNvPr>
          <p:cNvSpPr txBox="1"/>
          <p:nvPr/>
        </p:nvSpPr>
        <p:spPr>
          <a:xfrm>
            <a:off x="1935517" y="685114"/>
            <a:ext cx="1072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Sha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AC8A421-84AC-4C7F-9BA3-BCBB3304222D}"/>
              </a:ext>
            </a:extLst>
          </p:cNvPr>
          <p:cNvSpPr txBox="1"/>
          <p:nvPr/>
        </p:nvSpPr>
        <p:spPr>
          <a:xfrm>
            <a:off x="3218687" y="6172886"/>
            <a:ext cx="6141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Figure 5 Knee joint Safranin O/Fast green staining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513234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BA13F21-87A4-4183-8193-325DD502AA2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84248" y="1421837"/>
            <a:ext cx="3122939" cy="3648545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7B6B533C-A5AD-4270-955B-3167EE20F7A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89464" y="1421835"/>
            <a:ext cx="3122940" cy="3648547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743B83E6-8634-4581-84AD-8C819A1D4C4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94681" y="1431793"/>
            <a:ext cx="3122939" cy="362862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01EC362B-7F2F-4139-9C79-914764F52A4C}"/>
              </a:ext>
            </a:extLst>
          </p:cNvPr>
          <p:cNvSpPr txBox="1"/>
          <p:nvPr/>
        </p:nvSpPr>
        <p:spPr>
          <a:xfrm>
            <a:off x="8666898" y="934293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>
                <a:latin typeface="微软雅黑" panose="020B0503020204020204" pitchFamily="34" charset="-122"/>
                <a:ea typeface="微软雅黑" panose="020B0503020204020204" pitchFamily="34" charset="-122"/>
              </a:rPr>
              <a:t>DMM+Bai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30C38F6-28A6-41AD-A414-7B3BEA4803C2}"/>
              </a:ext>
            </a:extLst>
          </p:cNvPr>
          <p:cNvSpPr txBox="1"/>
          <p:nvPr/>
        </p:nvSpPr>
        <p:spPr>
          <a:xfrm>
            <a:off x="5340993" y="929663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DM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9540D0D-9A8C-4EB3-BD15-12E3C6A535F9}"/>
              </a:ext>
            </a:extLst>
          </p:cNvPr>
          <p:cNvSpPr txBox="1"/>
          <p:nvPr/>
        </p:nvSpPr>
        <p:spPr>
          <a:xfrm>
            <a:off x="1956782" y="929663"/>
            <a:ext cx="1072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Sha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BEFC942-B80E-43EF-8CEB-E20C45A431CC}"/>
              </a:ext>
            </a:extLst>
          </p:cNvPr>
          <p:cNvSpPr txBox="1"/>
          <p:nvPr/>
        </p:nvSpPr>
        <p:spPr>
          <a:xfrm>
            <a:off x="3714698" y="6121159"/>
            <a:ext cx="6141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Figure 6 Knee joint micro CT 3D reconstruction image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4572883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0CF9D2D-FF96-4F7D-93D9-2006C21A4DF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74828" y="1281798"/>
            <a:ext cx="2773710" cy="383654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8D0BA7D-E542-430B-9907-2214537CDC9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26373" y="1281798"/>
            <a:ext cx="2773710" cy="383654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BCB4AC7-1542-4968-A596-5B5CACD706E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77918" y="1281798"/>
            <a:ext cx="2773710" cy="383654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E6E611C5-B7A9-46E8-8AEA-2E761A82A81C}"/>
              </a:ext>
            </a:extLst>
          </p:cNvPr>
          <p:cNvSpPr txBox="1"/>
          <p:nvPr/>
        </p:nvSpPr>
        <p:spPr>
          <a:xfrm>
            <a:off x="8192648" y="791440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>
                <a:latin typeface="微软雅黑" panose="020B0503020204020204" pitchFamily="34" charset="-122"/>
                <a:ea typeface="微软雅黑" panose="020B0503020204020204" pitchFamily="34" charset="-122"/>
              </a:rPr>
              <a:t>DMM+Bai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13C295D-8EC9-4DA8-BBA9-3E66F0BD8B99}"/>
              </a:ext>
            </a:extLst>
          </p:cNvPr>
          <p:cNvSpPr txBox="1"/>
          <p:nvPr/>
        </p:nvSpPr>
        <p:spPr>
          <a:xfrm>
            <a:off x="4968853" y="791440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DM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965678A-D274-4956-A898-48D26B1A9DEC}"/>
              </a:ext>
            </a:extLst>
          </p:cNvPr>
          <p:cNvSpPr txBox="1"/>
          <p:nvPr/>
        </p:nvSpPr>
        <p:spPr>
          <a:xfrm>
            <a:off x="1999312" y="791440"/>
            <a:ext cx="1072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Sha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D74ACB0-5657-47DB-A788-4317AC201FFF}"/>
              </a:ext>
            </a:extLst>
          </p:cNvPr>
          <p:cNvSpPr txBox="1"/>
          <p:nvPr/>
        </p:nvSpPr>
        <p:spPr>
          <a:xfrm>
            <a:off x="3377999" y="5881894"/>
            <a:ext cx="6141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Figure 7 Knee joint Collagen II IHC staining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5659716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B8B5028E-4C4D-423A-98BE-3BBC4B9828A6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92696" y="39926"/>
            <a:ext cx="2638425" cy="197881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288A303-8274-4D99-8828-BB7D15C538D2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92696" y="2140190"/>
            <a:ext cx="2638425" cy="1978819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584012DE-3316-42CD-9377-80B904AE9EA5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92696" y="4188064"/>
            <a:ext cx="2638425" cy="1978819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45A3E44-9D54-4849-A5E8-1ACC80C14B6A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21931" y="39926"/>
            <a:ext cx="2638425" cy="197881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E5F28906-58C9-4DA6-8B3A-331278DB98CC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21931" y="2113995"/>
            <a:ext cx="2638425" cy="197881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ACED357-42B7-4017-A3EC-BAFB5AF8C2B8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21931" y="4188064"/>
            <a:ext cx="2638425" cy="197881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E96A3A2-19B2-4A9D-913E-E453F85CE319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163461" y="39925"/>
            <a:ext cx="2638425" cy="197881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F230DD6-1499-4BB0-85A6-580B14D3FBC3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163461" y="2140188"/>
            <a:ext cx="2638425" cy="197881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940F12A-101B-433C-99DC-0ADAEB1C4EB0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163461" y="4188063"/>
            <a:ext cx="2638425" cy="1978819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C1440BA7-5997-49CB-920E-9EE1B7385E7E}"/>
              </a:ext>
            </a:extLst>
          </p:cNvPr>
          <p:cNvSpPr txBox="1"/>
          <p:nvPr/>
        </p:nvSpPr>
        <p:spPr>
          <a:xfrm>
            <a:off x="7819155" y="-405400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>
                <a:latin typeface="微软雅黑" panose="020B0503020204020204" pitchFamily="34" charset="-122"/>
                <a:ea typeface="微软雅黑" panose="020B0503020204020204" pitchFamily="34" charset="-122"/>
              </a:rPr>
              <a:t>DMM+Bai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E5B6EDF-6AB3-4CFD-BE1F-8B1973CD5855}"/>
              </a:ext>
            </a:extLst>
          </p:cNvPr>
          <p:cNvSpPr txBox="1"/>
          <p:nvPr/>
        </p:nvSpPr>
        <p:spPr>
          <a:xfrm>
            <a:off x="5048390" y="-405400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DM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AC8BE17-C6E5-4DC2-98E4-D5B85F7933D2}"/>
              </a:ext>
            </a:extLst>
          </p:cNvPr>
          <p:cNvSpPr txBox="1"/>
          <p:nvPr/>
        </p:nvSpPr>
        <p:spPr>
          <a:xfrm>
            <a:off x="2434586" y="-424213"/>
            <a:ext cx="1072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Sha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67EDD82-DAD7-44D6-BF60-8F8B6D136BA6}"/>
              </a:ext>
            </a:extLst>
          </p:cNvPr>
          <p:cNvSpPr txBox="1"/>
          <p:nvPr/>
        </p:nvSpPr>
        <p:spPr>
          <a:xfrm>
            <a:off x="3507367" y="6448742"/>
            <a:ext cx="6141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Figure 7 Knee joint BAX IHC staining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0498213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7A69185-7923-4022-B2D3-1171DF9E4831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84162" y="24006"/>
            <a:ext cx="2638425" cy="197881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985A7041-E0FD-4E76-850D-5335D66922FA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84161" y="2109981"/>
            <a:ext cx="2638425" cy="1978819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F53396EB-F8CE-4D13-8805-893FE56C01AB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84161" y="4195956"/>
            <a:ext cx="2638425" cy="1978819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2BBFC3B-5552-4C52-8B0F-6928E8433BA2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17306" y="31141"/>
            <a:ext cx="2638427" cy="197882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C6C19DB-DB52-45FD-8BF0-E9215367E55A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17307" y="2109980"/>
            <a:ext cx="2638426" cy="197882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A24996C-8B9C-429D-80C6-C3685B684119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17305" y="4202885"/>
            <a:ext cx="2638427" cy="197882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D9941CB-CB7E-47B8-94C1-90BBB76355AA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72931" y="24006"/>
            <a:ext cx="2638426" cy="197882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B4CD055-A61F-4BF1-9B45-407433FE2F78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72931" y="2115296"/>
            <a:ext cx="2638426" cy="197882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1ACA7E0-BC0C-488B-9186-184EFA5B0700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72931" y="4202885"/>
            <a:ext cx="2638426" cy="197882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A1A26362-1535-43DF-9100-EB0150165B82}"/>
              </a:ext>
            </a:extLst>
          </p:cNvPr>
          <p:cNvSpPr txBox="1"/>
          <p:nvPr/>
        </p:nvSpPr>
        <p:spPr>
          <a:xfrm>
            <a:off x="7928626" y="-365770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>
                <a:latin typeface="微软雅黑" panose="020B0503020204020204" pitchFamily="34" charset="-122"/>
                <a:ea typeface="微软雅黑" panose="020B0503020204020204" pitchFamily="34" charset="-122"/>
              </a:rPr>
              <a:t>DMM+Bai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C26DB1A-580C-432E-90C5-356C75DED2AD}"/>
              </a:ext>
            </a:extLst>
          </p:cNvPr>
          <p:cNvSpPr txBox="1"/>
          <p:nvPr/>
        </p:nvSpPr>
        <p:spPr>
          <a:xfrm>
            <a:off x="5299900" y="-407868"/>
            <a:ext cx="132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DM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B2CA100-8AB9-46FB-8C20-FB5C1F7C1A3A}"/>
              </a:ext>
            </a:extLst>
          </p:cNvPr>
          <p:cNvSpPr txBox="1"/>
          <p:nvPr/>
        </p:nvSpPr>
        <p:spPr>
          <a:xfrm>
            <a:off x="2435248" y="-407868"/>
            <a:ext cx="1072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Sham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EED7B58-0F22-4E13-89C2-9702A9044251}"/>
              </a:ext>
            </a:extLst>
          </p:cNvPr>
          <p:cNvSpPr txBox="1"/>
          <p:nvPr/>
        </p:nvSpPr>
        <p:spPr>
          <a:xfrm>
            <a:off x="3678865" y="6455409"/>
            <a:ext cx="6141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Figure 7 Knee joint BCL 2 IHC staining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4945603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3E846AD-95CB-45C2-A5F6-D999AA2C7B1E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58680" y="281483"/>
            <a:ext cx="4375566" cy="141968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65400ADE-5389-479C-9FCF-C85FA4143CBF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528391" y="256948"/>
            <a:ext cx="4417215" cy="146875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119E844-ED68-410D-BBC2-E8808DC148E6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58680" y="1725706"/>
            <a:ext cx="4375566" cy="1419688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FFA83563-5FCF-4C5B-9647-89659BB6E8FC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528390" y="1725706"/>
            <a:ext cx="4417215" cy="1468758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D1D72B3-7016-4DD6-902D-BFC7769E8E4A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58680" y="3145394"/>
            <a:ext cx="4375566" cy="1419688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D149016-A618-495A-A067-7EC9CCB11227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528389" y="3145394"/>
            <a:ext cx="4417215" cy="1468758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953797E9-DBD6-402F-95F1-6FD76884D1A9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58680" y="4565082"/>
            <a:ext cx="4375566" cy="1419688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30DD424A-E954-458F-8010-94F96124BDE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528389" y="4565082"/>
            <a:ext cx="4497572" cy="1495477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6C3855F2-5101-4411-B07F-EB4216E748FA}"/>
              </a:ext>
            </a:extLst>
          </p:cNvPr>
          <p:cNvSpPr txBox="1"/>
          <p:nvPr/>
        </p:nvSpPr>
        <p:spPr>
          <a:xfrm>
            <a:off x="2506956" y="-160773"/>
            <a:ext cx="2657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Amplification curve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4C91AF7-A280-47CC-9C06-6B0D90CDD788}"/>
              </a:ext>
            </a:extLst>
          </p:cNvPr>
          <p:cNvSpPr txBox="1"/>
          <p:nvPr/>
        </p:nvSpPr>
        <p:spPr>
          <a:xfrm>
            <a:off x="7999619" y="-162916"/>
            <a:ext cx="20375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solubility curve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A9502D6C-A472-4A37-BCEE-54169D831879}"/>
              </a:ext>
            </a:extLst>
          </p:cNvPr>
          <p:cNvSpPr txBox="1"/>
          <p:nvPr/>
        </p:nvSpPr>
        <p:spPr>
          <a:xfrm>
            <a:off x="585897" y="671065"/>
            <a:ext cx="1072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actin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8376984-6598-4453-B556-6D1C8122CC97}"/>
              </a:ext>
            </a:extLst>
          </p:cNvPr>
          <p:cNvSpPr txBox="1"/>
          <p:nvPr/>
        </p:nvSpPr>
        <p:spPr>
          <a:xfrm>
            <a:off x="585899" y="3510441"/>
            <a:ext cx="1072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BCL 2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CD2E49A-9075-4A6B-AD54-5F03D255E8BB}"/>
              </a:ext>
            </a:extLst>
          </p:cNvPr>
          <p:cNvSpPr txBox="1"/>
          <p:nvPr/>
        </p:nvSpPr>
        <p:spPr>
          <a:xfrm>
            <a:off x="585898" y="2092773"/>
            <a:ext cx="1072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BAX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D069F20-744B-4BD8-999C-A1F0CC4C0EE6}"/>
              </a:ext>
            </a:extLst>
          </p:cNvPr>
          <p:cNvSpPr txBox="1"/>
          <p:nvPr/>
        </p:nvSpPr>
        <p:spPr>
          <a:xfrm>
            <a:off x="309450" y="4943488"/>
            <a:ext cx="13279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Caspase 3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054CCC8A-657C-495D-A50B-7F6F71ED8825}"/>
              </a:ext>
            </a:extLst>
          </p:cNvPr>
          <p:cNvSpPr txBox="1"/>
          <p:nvPr/>
        </p:nvSpPr>
        <p:spPr>
          <a:xfrm>
            <a:off x="4625947" y="6273800"/>
            <a:ext cx="23463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Figure 8  PCR 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933887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7</TotalTime>
  <Words>91</Words>
  <Application>Microsoft Office PowerPoint</Application>
  <PresentationFormat>宽屏</PresentationFormat>
  <Paragraphs>31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微软雅黑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star</dc:creator>
  <cp:lastModifiedBy>Yistar</cp:lastModifiedBy>
  <cp:revision>22</cp:revision>
  <dcterms:created xsi:type="dcterms:W3CDTF">2021-10-05T07:50:15Z</dcterms:created>
  <dcterms:modified xsi:type="dcterms:W3CDTF">2021-10-08T13:25:14Z</dcterms:modified>
</cp:coreProperties>
</file>